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61" d="100"/>
          <a:sy n="61" d="100"/>
        </p:scale>
        <p:origin x="21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ber%'!$B$39</c:f>
              <c:strCache>
                <c:ptCount val="1"/>
                <c:pt idx="0">
                  <c:v>N.Tu-CN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ber%'!$M$11:$T$11</c:f>
                <c:numCache>
                  <c:formatCode>General</c:formatCode>
                  <c:ptCount val="8"/>
                  <c:pt idx="0">
                    <c:v>0.33333333333333337</c:v>
                  </c:pt>
                  <c:pt idx="1">
                    <c:v>2.7284509239574839</c:v>
                  </c:pt>
                  <c:pt idx="2">
                    <c:v>1.452966314513559</c:v>
                  </c:pt>
                  <c:pt idx="3">
                    <c:v>1.855921454276674</c:v>
                  </c:pt>
                  <c:pt idx="4">
                    <c:v>1.763834207376394</c:v>
                  </c:pt>
                  <c:pt idx="5">
                    <c:v>1.1547005383792517</c:v>
                  </c:pt>
                  <c:pt idx="6">
                    <c:v>0.57735026918962584</c:v>
                  </c:pt>
                  <c:pt idx="7">
                    <c:v>0.577350269189625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ber%'!$C$38:$J$38</c:f>
              <c:strCache>
                <c:ptCount val="8"/>
                <c:pt idx="0">
                  <c:v>10-20</c:v>
                </c:pt>
                <c:pt idx="1">
                  <c:v>21-30</c:v>
                </c:pt>
                <c:pt idx="2">
                  <c:v>31-40</c:v>
                </c:pt>
                <c:pt idx="3">
                  <c:v>41-50</c:v>
                </c:pt>
                <c:pt idx="4">
                  <c:v>51-60</c:v>
                </c:pt>
                <c:pt idx="5">
                  <c:v>61-70</c:v>
                </c:pt>
                <c:pt idx="6">
                  <c:v>71-80</c:v>
                </c:pt>
                <c:pt idx="7">
                  <c:v>81-90</c:v>
                </c:pt>
              </c:strCache>
            </c:strRef>
          </c:cat>
          <c:val>
            <c:numRef>
              <c:f>'Fiber%'!$C$39:$J$39</c:f>
              <c:numCache>
                <c:formatCode>General</c:formatCode>
                <c:ptCount val="8"/>
                <c:pt idx="0">
                  <c:v>0.33333333333333331</c:v>
                </c:pt>
                <c:pt idx="1">
                  <c:v>6.333333333333333</c:v>
                </c:pt>
                <c:pt idx="2">
                  <c:v>12.666666666666666</c:v>
                </c:pt>
                <c:pt idx="3">
                  <c:v>38.333333333333336</c:v>
                </c:pt>
                <c:pt idx="4">
                  <c:v>29.333333333333332</c:v>
                </c:pt>
                <c:pt idx="5">
                  <c:v>10</c:v>
                </c:pt>
                <c:pt idx="6">
                  <c:v>2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1D-47F2-BA83-51F1EE8E2A20}"/>
            </c:ext>
          </c:extLst>
        </c:ser>
        <c:ser>
          <c:idx val="1"/>
          <c:order val="1"/>
          <c:tx>
            <c:strRef>
              <c:f>'Fiber%'!$B$40</c:f>
              <c:strCache>
                <c:ptCount val="1"/>
                <c:pt idx="0">
                  <c:v>N.Tu-SkT6Tg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19050"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ber%'!$M$19:$T$19</c:f>
                <c:numCache>
                  <c:formatCode>General</c:formatCode>
                  <c:ptCount val="8"/>
                  <c:pt idx="0">
                    <c:v>0.66666666666666674</c:v>
                  </c:pt>
                  <c:pt idx="1">
                    <c:v>0.88191710368819609</c:v>
                  </c:pt>
                  <c:pt idx="2">
                    <c:v>2.3333333333333361</c:v>
                  </c:pt>
                  <c:pt idx="3">
                    <c:v>0.88191710368819687</c:v>
                  </c:pt>
                  <c:pt idx="4">
                    <c:v>1.7320508075688774</c:v>
                  </c:pt>
                  <c:pt idx="5">
                    <c:v>0</c:v>
                  </c:pt>
                  <c:pt idx="6">
                    <c:v>0.3333333333333332</c:v>
                  </c:pt>
                  <c:pt idx="7">
                    <c:v>0.577350269189625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ber%'!$C$38:$J$38</c:f>
              <c:strCache>
                <c:ptCount val="8"/>
                <c:pt idx="0">
                  <c:v>10-20</c:v>
                </c:pt>
                <c:pt idx="1">
                  <c:v>21-30</c:v>
                </c:pt>
                <c:pt idx="2">
                  <c:v>31-40</c:v>
                </c:pt>
                <c:pt idx="3">
                  <c:v>41-50</c:v>
                </c:pt>
                <c:pt idx="4">
                  <c:v>51-60</c:v>
                </c:pt>
                <c:pt idx="5">
                  <c:v>61-70</c:v>
                </c:pt>
                <c:pt idx="6">
                  <c:v>71-80</c:v>
                </c:pt>
                <c:pt idx="7">
                  <c:v>81-90</c:v>
                </c:pt>
              </c:strCache>
            </c:strRef>
          </c:cat>
          <c:val>
            <c:numRef>
              <c:f>'Fiber%'!$C$40:$J$40</c:f>
              <c:numCache>
                <c:formatCode>General</c:formatCode>
                <c:ptCount val="8"/>
                <c:pt idx="0">
                  <c:v>0.66666666666666663</c:v>
                </c:pt>
                <c:pt idx="1">
                  <c:v>7.666666666666667</c:v>
                </c:pt>
                <c:pt idx="2">
                  <c:v>22.666666666666668</c:v>
                </c:pt>
                <c:pt idx="3">
                  <c:v>36.333333333333336</c:v>
                </c:pt>
                <c:pt idx="4">
                  <c:v>28</c:v>
                </c:pt>
                <c:pt idx="5">
                  <c:v>3</c:v>
                </c:pt>
                <c:pt idx="6">
                  <c:v>1.6666666666666667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1D-47F2-BA83-51F1EE8E2A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374334064"/>
        <c:axId val="374338000"/>
      </c:barChart>
      <c:catAx>
        <c:axId val="374334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oss-sectional diameter (µ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338000"/>
        <c:crosses val="autoZero"/>
        <c:auto val="1"/>
        <c:lblAlgn val="ctr"/>
        <c:lblOffset val="100"/>
        <c:noMultiLvlLbl val="0"/>
      </c:catAx>
      <c:valAx>
        <c:axId val="3743380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ber size distribution (%)</a:t>
                </a:r>
              </a:p>
            </c:rich>
          </c:tx>
          <c:layout>
            <c:manualLayout>
              <c:xMode val="edge"/>
              <c:yMode val="edge"/>
              <c:x val="3.2811334824757642E-2"/>
              <c:y val="3.30374227415121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334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culations!$C$107</c:f>
              <c:strCache>
                <c:ptCount val="1"/>
                <c:pt idx="0">
                  <c:v>Fiber siz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alculations!$D$108:$E$108</c:f>
                <c:numCache>
                  <c:formatCode>General</c:formatCode>
                  <c:ptCount val="2"/>
                  <c:pt idx="0">
                    <c:v>1.1221412428289976</c:v>
                  </c:pt>
                  <c:pt idx="1">
                    <c:v>0.994746049099135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Calculations!$D$106:$E$106</c:f>
              <c:strCache>
                <c:ptCount val="2"/>
                <c:pt idx="0">
                  <c:v>N.Tu-CN</c:v>
                </c:pt>
                <c:pt idx="1">
                  <c:v>N.Tu-Sk.T6Tg</c:v>
                </c:pt>
              </c:strCache>
            </c:strRef>
          </c:cat>
          <c:val>
            <c:numRef>
              <c:f>Calculations!$D$107:$E$107</c:f>
              <c:numCache>
                <c:formatCode>General</c:formatCode>
                <c:ptCount val="2"/>
                <c:pt idx="0">
                  <c:v>47.203364485981297</c:v>
                </c:pt>
                <c:pt idx="1">
                  <c:v>44.8527272727272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3C-4B9C-8851-EC608DA46F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505827976"/>
        <c:axId val="505828304"/>
      </c:barChart>
      <c:catAx>
        <c:axId val="505827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828304"/>
        <c:crosses val="autoZero"/>
        <c:auto val="1"/>
        <c:lblAlgn val="ctr"/>
        <c:lblOffset val="100"/>
        <c:noMultiLvlLbl val="0"/>
      </c:catAx>
      <c:valAx>
        <c:axId val="505828304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oss-sectional Diameter (µ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0582797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99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77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330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677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996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73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84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043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561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280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4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9D736-677A-47CB-A75B-A1445F94C901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CA4DD-6E6D-465B-9059-0651A13BA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35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05164" y="178465"/>
            <a:ext cx="6752836" cy="8757507"/>
            <a:chOff x="105164" y="131167"/>
            <a:chExt cx="6752836" cy="8757507"/>
          </a:xfrm>
        </p:grpSpPr>
        <p:grpSp>
          <p:nvGrpSpPr>
            <p:cNvPr id="15" name="Group 14"/>
            <p:cNvGrpSpPr/>
            <p:nvPr/>
          </p:nvGrpSpPr>
          <p:grpSpPr>
            <a:xfrm>
              <a:off x="112483" y="348577"/>
              <a:ext cx="6745517" cy="3379360"/>
              <a:chOff x="112483" y="348577"/>
              <a:chExt cx="6745517" cy="3379360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3412404" y="348577"/>
                <a:ext cx="11671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.Tu-Sk.T6Tg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12483" y="348577"/>
                <a:ext cx="7888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.Tu</a:t>
                </a:r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/>
              <a:srcRect l="3514" t="19291" r="52042" b="15637"/>
              <a:stretch/>
            </p:blipFill>
            <p:spPr>
              <a:xfrm>
                <a:off x="123095" y="597876"/>
                <a:ext cx="3200398" cy="3130061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/>
              <a:srcRect l="55771" t="4259" r="-2659" b="30668"/>
              <a:stretch/>
            </p:blipFill>
            <p:spPr>
              <a:xfrm>
                <a:off x="3481753" y="597875"/>
                <a:ext cx="3376247" cy="3130061"/>
              </a:xfrm>
              <a:prstGeom prst="rect">
                <a:avLst/>
              </a:prstGeom>
            </p:spPr>
          </p:pic>
          <p:grpSp>
            <p:nvGrpSpPr>
              <p:cNvPr id="11" name="Group 10"/>
              <p:cNvGrpSpPr/>
              <p:nvPr/>
            </p:nvGrpSpPr>
            <p:grpSpPr>
              <a:xfrm>
                <a:off x="2722450" y="3396416"/>
                <a:ext cx="619080" cy="261610"/>
                <a:chOff x="2596975" y="4122808"/>
                <a:chExt cx="619080" cy="261610"/>
              </a:xfrm>
            </p:grpSpPr>
            <p:cxnSp>
              <p:nvCxnSpPr>
                <p:cNvPr id="9" name="Straight Connector 8"/>
                <p:cNvCxnSpPr/>
                <p:nvPr/>
              </p:nvCxnSpPr>
              <p:spPr>
                <a:xfrm>
                  <a:off x="2615013" y="4332718"/>
                  <a:ext cx="54693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>
                  <a:off x="2596975" y="4122808"/>
                  <a:ext cx="61908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0µm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6010212" y="3381514"/>
                <a:ext cx="619080" cy="261610"/>
                <a:chOff x="2578938" y="4107906"/>
                <a:chExt cx="619080" cy="261610"/>
              </a:xfrm>
            </p:grpSpPr>
            <p:cxnSp>
              <p:nvCxnSpPr>
                <p:cNvPr id="13" name="Straight Connector 12"/>
                <p:cNvCxnSpPr/>
                <p:nvPr/>
              </p:nvCxnSpPr>
              <p:spPr>
                <a:xfrm>
                  <a:off x="2615013" y="4332718"/>
                  <a:ext cx="54693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/>
                <p:cNvSpPr txBox="1"/>
                <p:nvPr/>
              </p:nvSpPr>
              <p:spPr>
                <a:xfrm>
                  <a:off x="2578938" y="4107906"/>
                  <a:ext cx="61908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0µm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aphicFrame>
          <p:nvGraphicFramePr>
            <p:cNvPr id="34" name="Chart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98100271"/>
                </p:ext>
              </p:extLst>
            </p:nvPr>
          </p:nvGraphicFramePr>
          <p:xfrm>
            <a:off x="1513459" y="6174818"/>
            <a:ext cx="4257675" cy="2362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7" name="TextBox 36"/>
            <p:cNvSpPr txBox="1"/>
            <p:nvPr/>
          </p:nvSpPr>
          <p:spPr>
            <a:xfrm>
              <a:off x="105164" y="131167"/>
              <a:ext cx="338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32012" y="603631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33683" y="3872455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307750" y="188285"/>
              <a:ext cx="338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1407448" y="3977234"/>
              <a:ext cx="3475230" cy="2122927"/>
              <a:chOff x="1407448" y="3977234"/>
              <a:chExt cx="3475230" cy="2122927"/>
            </a:xfrm>
          </p:grpSpPr>
          <p:graphicFrame>
            <p:nvGraphicFramePr>
              <p:cNvPr id="36" name="Chart 3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24782101"/>
                  </p:ext>
                </p:extLst>
              </p:nvPr>
            </p:nvGraphicFramePr>
            <p:xfrm>
              <a:off x="1407448" y="3977234"/>
              <a:ext cx="3475230" cy="21229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44" name="Group 43"/>
              <p:cNvGrpSpPr/>
              <p:nvPr/>
            </p:nvGrpSpPr>
            <p:grpSpPr>
              <a:xfrm>
                <a:off x="3013953" y="4204982"/>
                <a:ext cx="914400" cy="246221"/>
                <a:chOff x="5500546" y="6109898"/>
                <a:chExt cx="914400" cy="246221"/>
              </a:xfrm>
            </p:grpSpPr>
            <p:cxnSp>
              <p:nvCxnSpPr>
                <p:cNvPr id="42" name="Straight Connector 41"/>
                <p:cNvCxnSpPr/>
                <p:nvPr/>
              </p:nvCxnSpPr>
              <p:spPr>
                <a:xfrm>
                  <a:off x="5500546" y="6318187"/>
                  <a:ext cx="914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/>
                <p:cNvSpPr txBox="1"/>
                <p:nvPr/>
              </p:nvSpPr>
              <p:spPr>
                <a:xfrm>
                  <a:off x="5835757" y="6109898"/>
                  <a:ext cx="3626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" name="TextBox 1"/>
            <p:cNvSpPr txBox="1"/>
            <p:nvPr/>
          </p:nvSpPr>
          <p:spPr>
            <a:xfrm>
              <a:off x="2948325" y="8611675"/>
              <a:ext cx="88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87766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29</Words>
  <Application>Microsoft Office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, Sadhana [BSD] - SUR</dc:creator>
  <cp:lastModifiedBy>Samant, Sadhana [BSD] - SUR</cp:lastModifiedBy>
  <cp:revision>16</cp:revision>
  <dcterms:created xsi:type="dcterms:W3CDTF">2020-06-29T18:45:05Z</dcterms:created>
  <dcterms:modified xsi:type="dcterms:W3CDTF">2020-08-13T15:42:51Z</dcterms:modified>
</cp:coreProperties>
</file>